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16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F5D25C-F838-49A1-B4C8-AC41E2696B36}" type="datetimeFigureOut">
              <a:rPr lang="en-GB" smtClean="0"/>
              <a:pPr/>
              <a:t>12/02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74BBE-B666-4ABF-B4C2-2D0E4F7A1E52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ure S1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548640" y="1712640"/>
            <a:ext cx="5760720" cy="539953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48680" y="7257256"/>
            <a:ext cx="5472608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1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henotypes of all plants used in the silencing mutants fecundity screen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539884" y="499537"/>
            <a:ext cx="5616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itchFamily="18" charset="0"/>
                <a:cs typeface="Times New Roman" pitchFamily="18" charset="0"/>
              </a:rPr>
              <a:t>Supporting Information Figs S1-S7, Table S1</a:t>
            </a:r>
            <a:endParaRPr lang="en-GB" sz="1200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ure S2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984248" y="1136576"/>
            <a:ext cx="2889504" cy="597103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92696" y="7329264"/>
            <a:ext cx="54006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2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Investigation into temporal response of Col-0 plants to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M.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ersica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GPA) infestation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ure S3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615184" y="776536"/>
            <a:ext cx="1627632" cy="1627632"/>
          </a:xfrm>
          <a:prstGeom prst="rect">
            <a:avLst/>
          </a:prstGeom>
        </p:spPr>
      </p:pic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692696" y="2504728"/>
            <a:ext cx="6093296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. S3 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Induction of the pathogen response-related gene MPK3 is highest in </a:t>
            </a:r>
            <a:r>
              <a:rPr kumimoji="0" lang="en-US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cl1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lants.</a:t>
            </a: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pic>
        <p:nvPicPr>
          <p:cNvPr id="4" name="Picture 3" descr="Figure S4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655064" y="4048848"/>
            <a:ext cx="3547872" cy="3712464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76672" y="7905328"/>
            <a:ext cx="597666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4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Expression levels of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AD3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HE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t 24hpi and 48hpi in Col-0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dcl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dcl2/3/4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plants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ure S5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1677924" y="512480"/>
            <a:ext cx="3502152" cy="192024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980728" y="2515761"/>
            <a:ext cx="525658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5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phid fecundity trials on Arabidopsis SA and JA pathway mutants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3" descr="Figure S6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1604772" y="3614496"/>
            <a:ext cx="3648456" cy="5010912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548680" y="8697416"/>
            <a:ext cx="597666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6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Spatial induction of a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YP71B15p::GU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PAD3p::GU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 transgene following aphid feeding. (a) no treatment negative control, (b) Botrytis lesion positive control, (c-h) aphid feeding sites on lea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midvein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with varying degrees and patterns of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transgen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induction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Figure S7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2204864" y="2432720"/>
            <a:ext cx="2142057" cy="1973833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20688" y="4635351"/>
            <a:ext cx="597666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Fig. S7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phid fecundity trial on Arabidopsis Col-0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dcl1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dcl2/3/4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using a previously described fecundity/survival assay protocol.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620688" y="1568624"/>
          <a:ext cx="5544615" cy="5638788"/>
        </p:xfrm>
        <a:graphic>
          <a:graphicData uri="http://schemas.openxmlformats.org/drawingml/2006/table">
            <a:tbl>
              <a:tblPr/>
              <a:tblGrid>
                <a:gridCol w="1367648"/>
                <a:gridCol w="1469870"/>
                <a:gridCol w="2707097"/>
              </a:tblGrid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eference Genes 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 Name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dentifier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quence (5' -&gt; 3')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CT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3g1878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GATGAGGCAGGTCCAGGAAT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GTTTGTCACACACAAGTGCAT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4663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4663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GCGTTTTGGTTAATCTGTCT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CCGTGTTGTAACCGCTCTT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EX4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2576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GCAACCTCCTCAAGTTC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CACAGACTGAAGCGTCCAA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arget Genes 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ene Name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dentifier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000" b="1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quence (5' -&gt; 3')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2g1461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GTTGCAGCCTATGCTCGGA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CCGCTACCCCAGGCTAAGTT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LOX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3g4514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GCAAGCTCCAATATCTAGAAGGAGT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CGGTAACACCATGCTCAGAGGTA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SP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2477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GTTAGGGACCGGAGCATCAA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AACGGTCACTGAGTATGATGGGT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DF1.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4442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CCATCATCACCCTTATCTTCG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TGTCCCACTTGGCTTCTC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HEL/PR4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3g0472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GTGAGAATAGTGGACCAATG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ATGAGATGGCCTTGTTGATAG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AD3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3g2683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GCTCCCAAGACAGACAAT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GTTTTGGATCACGACCCAT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YP79B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4g3995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CTCCGGTTTATCTCGTTCAGTA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CGTGTCTCATTCTCAGGTAGCTT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YP83B1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4g3150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GCTGGTAGATATGGCGTGA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AAGGGACCCGAATATTAAACATC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YP81F2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5g5722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GGCTATGCGTAAACTCGT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GGTAAACTTCAAAATGGTGGTCA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1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PK3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t3g45640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F  TCCGAATGGCTACTTAGTATCTTT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R  TGGAGCTACACTTAATCACTAGCAG</a:t>
                      </a: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84667"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000" b="0" i="0" u="none" strike="noStrike" dirty="0">
                        <a:solidFill>
                          <a:srgbClr val="000000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4233" marR="4233" marT="423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476672" y="7545288"/>
            <a:ext cx="540060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Table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1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Oligonucleotide primers used for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PCR experiments</a:t>
            </a:r>
            <a:endParaRPr lang="en-GB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77</Words>
  <Application>Microsoft Office PowerPoint</Application>
  <PresentationFormat>A4 Paper (210x297 mm)</PresentationFormat>
  <Paragraphs>69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raeme Kettles</dc:creator>
  <cp:lastModifiedBy>Allen, Judith</cp:lastModifiedBy>
  <cp:revision>7</cp:revision>
  <dcterms:created xsi:type="dcterms:W3CDTF">2013-02-06T16:38:47Z</dcterms:created>
  <dcterms:modified xsi:type="dcterms:W3CDTF">2013-02-12T09:19:02Z</dcterms:modified>
</cp:coreProperties>
</file>